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8999538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87D945C-14AD-493C-AA20-ED8514CEE211}" v="2" dt="2023-08-03T02:37:37.76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1273" autoAdjust="0"/>
  </p:normalViewPr>
  <p:slideViewPr>
    <p:cSldViewPr snapToGrid="0">
      <p:cViewPr varScale="1">
        <p:scale>
          <a:sx n="110" d="100"/>
          <a:sy n="110" d="100"/>
        </p:scale>
        <p:origin x="100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임승혁" userId="50080d77-0d6e-4880-96a7-58e4dd6aba5c" providerId="ADAL" clId="{66EA72B9-801F-499E-8BC2-82E27716909D}"/>
    <pc:docChg chg="undo custSel modSld">
      <pc:chgData name="임승혁" userId="50080d77-0d6e-4880-96a7-58e4dd6aba5c" providerId="ADAL" clId="{66EA72B9-801F-499E-8BC2-82E27716909D}" dt="2023-07-03T03:16:59.500" v="115" actId="14100"/>
      <pc:docMkLst>
        <pc:docMk/>
      </pc:docMkLst>
      <pc:sldChg chg="modSp mod">
        <pc:chgData name="임승혁" userId="50080d77-0d6e-4880-96a7-58e4dd6aba5c" providerId="ADAL" clId="{66EA72B9-801F-499E-8BC2-82E27716909D}" dt="2023-07-03T03:16:59.500" v="115" actId="14100"/>
        <pc:sldMkLst>
          <pc:docMk/>
          <pc:sldMk cId="3431822228" sldId="256"/>
        </pc:sldMkLst>
        <pc:spChg chg="mod">
          <ac:chgData name="임승혁" userId="50080d77-0d6e-4880-96a7-58e4dd6aba5c" providerId="ADAL" clId="{66EA72B9-801F-499E-8BC2-82E27716909D}" dt="2023-07-03T03:12:00.836" v="59" actId="20577"/>
          <ac:spMkLst>
            <pc:docMk/>
            <pc:sldMk cId="3431822228" sldId="256"/>
            <ac:spMk id="5" creationId="{A2B06BF4-8BA6-EA6E-3403-93919840A4E6}"/>
          </ac:spMkLst>
        </pc:spChg>
        <pc:spChg chg="mod">
          <ac:chgData name="임승혁" userId="50080d77-0d6e-4880-96a7-58e4dd6aba5c" providerId="ADAL" clId="{66EA72B9-801F-499E-8BC2-82E27716909D}" dt="2023-07-03T03:16:45.214" v="84" actId="1035"/>
          <ac:spMkLst>
            <pc:docMk/>
            <pc:sldMk cId="3431822228" sldId="256"/>
            <ac:spMk id="6" creationId="{BF25BFE9-B681-C1BE-A27A-ABB17CCE3961}"/>
          </ac:spMkLst>
        </pc:spChg>
        <pc:picChg chg="mod">
          <ac:chgData name="임승혁" userId="50080d77-0d6e-4880-96a7-58e4dd6aba5c" providerId="ADAL" clId="{66EA72B9-801F-499E-8BC2-82E27716909D}" dt="2023-07-03T03:16:59.500" v="115" actId="14100"/>
          <ac:picMkLst>
            <pc:docMk/>
            <pc:sldMk cId="3431822228" sldId="256"/>
            <ac:picMk id="4" creationId="{5128FDE4-C49C-3003-319C-CA1C90D4F163}"/>
          </ac:picMkLst>
        </pc:picChg>
        <pc:cxnChg chg="mod">
          <ac:chgData name="임승혁" userId="50080d77-0d6e-4880-96a7-58e4dd6aba5c" providerId="ADAL" clId="{66EA72B9-801F-499E-8BC2-82E27716909D}" dt="2023-07-03T03:16:48.680" v="104" actId="1035"/>
          <ac:cxnSpMkLst>
            <pc:docMk/>
            <pc:sldMk cId="3431822228" sldId="256"/>
            <ac:cxnSpMk id="8" creationId="{ACE8C632-8FAA-0062-92DC-0D02AE043F86}"/>
          </ac:cxnSpMkLst>
        </pc:cxnChg>
      </pc:sldChg>
    </pc:docChg>
  </pc:docChgLst>
  <pc:docChgLst>
    <pc:chgData name="임승혁" userId="50080d77-0d6e-4880-96a7-58e4dd6aba5c" providerId="ADAL" clId="{287D945C-14AD-493C-AA20-ED8514CEE211}"/>
    <pc:docChg chg="undo custSel addSld delSld modSld">
      <pc:chgData name="임승혁" userId="50080d77-0d6e-4880-96a7-58e4dd6aba5c" providerId="ADAL" clId="{287D945C-14AD-493C-AA20-ED8514CEE211}" dt="2023-08-03T02:37:41.746" v="21" actId="1076"/>
      <pc:docMkLst>
        <pc:docMk/>
      </pc:docMkLst>
      <pc:sldChg chg="modSp mod">
        <pc:chgData name="임승혁" userId="50080d77-0d6e-4880-96a7-58e4dd6aba5c" providerId="ADAL" clId="{287D945C-14AD-493C-AA20-ED8514CEE211}" dt="2023-08-03T02:37:41.746" v="21" actId="1076"/>
        <pc:sldMkLst>
          <pc:docMk/>
          <pc:sldMk cId="3431822228" sldId="256"/>
        </pc:sldMkLst>
        <pc:picChg chg="mod modCrop">
          <ac:chgData name="임승혁" userId="50080d77-0d6e-4880-96a7-58e4dd6aba5c" providerId="ADAL" clId="{287D945C-14AD-493C-AA20-ED8514CEE211}" dt="2023-08-03T02:37:41.746" v="21" actId="1076"/>
          <ac:picMkLst>
            <pc:docMk/>
            <pc:sldMk cId="3431822228" sldId="256"/>
            <ac:picMk id="4" creationId="{5128FDE4-C49C-3003-319C-CA1C90D4F163}"/>
          </ac:picMkLst>
        </pc:picChg>
      </pc:sldChg>
      <pc:sldChg chg="new del">
        <pc:chgData name="임승혁" userId="50080d77-0d6e-4880-96a7-58e4dd6aba5c" providerId="ADAL" clId="{287D945C-14AD-493C-AA20-ED8514CEE211}" dt="2023-08-03T02:31:00.410" v="5" actId="47"/>
        <pc:sldMkLst>
          <pc:docMk/>
          <pc:sldMk cId="1055875085" sldId="25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2A8ACC-800C-411D-A947-8DB322DD5BD6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500188" y="1143000"/>
            <a:ext cx="3857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55FC58-540C-479B-B142-3AE2D6087CD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004222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55FC58-540C-479B-B142-3AE2D6087CD7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69765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178222"/>
            <a:ext cx="7649607" cy="250642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3781306"/>
            <a:ext cx="6749654" cy="1738167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7915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2438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383297"/>
            <a:ext cx="1940525" cy="610108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383297"/>
            <a:ext cx="5709082" cy="610108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3249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2169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1794831"/>
            <a:ext cx="7762102" cy="2994714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4817876"/>
            <a:ext cx="7762102" cy="1574849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8316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1916484"/>
            <a:ext cx="3824804" cy="456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1916484"/>
            <a:ext cx="3824804" cy="456789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6402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383299"/>
            <a:ext cx="7762102" cy="1391534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1764832"/>
            <a:ext cx="380722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2629749"/>
            <a:ext cx="3807226" cy="386796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1764832"/>
            <a:ext cx="3825976" cy="864917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2629749"/>
            <a:ext cx="3825976" cy="386796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73475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4178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4178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036570"/>
            <a:ext cx="4556016" cy="5116178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1387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479954"/>
            <a:ext cx="2902585" cy="1679840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036570"/>
            <a:ext cx="4556016" cy="5116178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2159794"/>
            <a:ext cx="2902585" cy="4001285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759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383299"/>
            <a:ext cx="7762102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1916484"/>
            <a:ext cx="7762102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6A00F3-C7C9-4822-8FEA-C770EFCB85E1}" type="datetimeFigureOut">
              <a:rPr lang="ko-KR" altLang="en-US" smtClean="0"/>
              <a:t>2023-08-0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6672698"/>
            <a:ext cx="3037344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6672698"/>
            <a:ext cx="2024896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633CC0-DD80-49E8-9814-068727A027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5336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899952" rtl="0" eaLnBrk="1" latinLnBrk="1" hangingPunct="1">
        <a:lnSpc>
          <a:spcPct val="90000"/>
        </a:lnSpc>
        <a:spcBef>
          <a:spcPct val="0"/>
        </a:spcBef>
        <a:buNone/>
        <a:defRPr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1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1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1" hangingPunct="1">
        <a:defRPr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5128FDE4-C49C-3003-319C-CA1C90D4F16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89" b="2689"/>
          <a:stretch/>
        </p:blipFill>
        <p:spPr bwMode="auto">
          <a:xfrm>
            <a:off x="604713" y="925107"/>
            <a:ext cx="7813717" cy="5951101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2B06BF4-8BA6-EA6E-3403-93919840A4E6}"/>
              </a:ext>
            </a:extLst>
          </p:cNvPr>
          <p:cNvSpPr txBox="1"/>
          <p:nvPr/>
        </p:nvSpPr>
        <p:spPr>
          <a:xfrm>
            <a:off x="134936" y="33637"/>
            <a:ext cx="8753273" cy="8728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800" b="1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l Digital Content 7. </a:t>
            </a:r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Comparison of survival curves after waitlisting of patients with a MELD score ≥30, </a:t>
            </a:r>
            <a:r>
              <a:rPr lang="en-US" altLang="ko-KR" b="1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</a:rPr>
              <a:t>according to their actual treatment</a:t>
            </a:r>
            <a:r>
              <a:rPr lang="en-US" altLang="ko-KR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</a:rPr>
              <a:t>.</a:t>
            </a:r>
            <a:endParaRPr lang="ko-KR" altLang="ko-KR" sz="1800" b="1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F25BFE9-B681-C1BE-A27A-ABB17CCE3961}"/>
              </a:ext>
            </a:extLst>
          </p:cNvPr>
          <p:cNvSpPr txBox="1"/>
          <p:nvPr/>
        </p:nvSpPr>
        <p:spPr>
          <a:xfrm>
            <a:off x="134936" y="6876208"/>
            <a:ext cx="8753273" cy="3191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1">
              <a:lnSpc>
                <a:spcPct val="150000"/>
              </a:lnSpc>
              <a:spcAft>
                <a:spcPts val="800"/>
              </a:spcAft>
            </a:pPr>
            <a:r>
              <a:rPr lang="en-US" altLang="ko-KR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MELD,</a:t>
            </a:r>
            <a:r>
              <a:rPr lang="ko-KR" altLang="en-US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1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Medel</a:t>
            </a:r>
            <a:r>
              <a:rPr lang="ko-KR" altLang="en-US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for</a:t>
            </a:r>
            <a:r>
              <a:rPr lang="ko-KR" altLang="en-US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 </a:t>
            </a:r>
            <a:r>
              <a:rPr lang="en-US" altLang="ko-KR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End-stage Liver Disease.</a:t>
            </a:r>
            <a:endParaRPr lang="ko-KR" altLang="ko-KR" sz="1050" kern="100" dirty="0">
              <a:effectLst/>
              <a:latin typeface="Calibri" panose="020F050202020403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ACE8C632-8FAA-0062-92DC-0D02AE043F86}"/>
              </a:ext>
            </a:extLst>
          </p:cNvPr>
          <p:cNvCxnSpPr>
            <a:cxnSpLocks/>
          </p:cNvCxnSpPr>
          <p:nvPr/>
        </p:nvCxnSpPr>
        <p:spPr>
          <a:xfrm>
            <a:off x="134936" y="6947458"/>
            <a:ext cx="849535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4318222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1</TotalTime>
  <Words>35</Words>
  <Application>Microsoft Office PowerPoint</Application>
  <PresentationFormat>사용자 지정</PresentationFormat>
  <Paragraphs>3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im Seung Hyuk</dc:creator>
  <cp:lastModifiedBy>임승혁</cp:lastModifiedBy>
  <cp:revision>4</cp:revision>
  <dcterms:created xsi:type="dcterms:W3CDTF">2023-05-09T01:23:50Z</dcterms:created>
  <dcterms:modified xsi:type="dcterms:W3CDTF">2023-08-03T02:37:42Z</dcterms:modified>
</cp:coreProperties>
</file>